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68" r:id="rId2"/>
    <p:sldId id="267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0"/>
    <p:restoredTop sz="94662"/>
  </p:normalViewPr>
  <p:slideViewPr>
    <p:cSldViewPr snapToGrid="0" snapToObjects="1">
      <p:cViewPr varScale="1">
        <p:scale>
          <a:sx n="74" d="100"/>
          <a:sy n="74" d="100"/>
        </p:scale>
        <p:origin x="552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B2A7F472-7E44-B243-9E2A-655C7B2DD0D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xmlns="" id="{D65D0C7B-9DAC-D946-9113-9C2D5D71A68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GB"/>
              <a:t>Click to edit Master subtitle style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41C493F4-0CDB-CC46-B2D5-DCC78C415DF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DAD356-D41E-D248-AA75-067A13486B5E}" type="datetimeFigureOut">
              <a:rPr lang="en-US" smtClean="0"/>
              <a:t>12/9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5244C28A-3E01-B640-9D8C-B576F6F889E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15802717-74F3-0E4F-AC81-56069AE494B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701C66-3126-D34B-BB29-C52EAB5200F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783190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186483FD-70FC-274C-BCDC-F8427033F33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xmlns="" id="{59367D94-FD69-CA47-82D3-B33C9662FCB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842D7AE1-8196-5047-9102-EEC9708040D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DAD356-D41E-D248-AA75-067A13486B5E}" type="datetimeFigureOut">
              <a:rPr lang="en-US" smtClean="0"/>
              <a:t>12/9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FDD5C1B9-B1DA-034B-95D4-ACA1DD6D634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4430F857-A218-1041-84A9-4FD9AF576FD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701C66-3126-D34B-BB29-C52EAB5200F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2895941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xmlns="" id="{637C1CE9-B313-924B-BEFF-2FC1FD093E5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xmlns="" id="{B28B4E01-FD74-5447-8D81-FD259A421B3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02E562BF-14D1-594D-A716-751BD4BDBC2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DAD356-D41E-D248-AA75-067A13486B5E}" type="datetimeFigureOut">
              <a:rPr lang="en-US" smtClean="0"/>
              <a:t>12/9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17204CDF-7EFA-9046-9A69-A452B3B67F2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592D922F-A620-A24F-8121-416DBB15DCD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701C66-3126-D34B-BB29-C52EAB5200F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3925978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4BC976F2-49FD-B645-83E4-86496878537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4DE80F89-896B-F044-A972-55C9ECDDF94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87990949-9B11-9541-BC18-6522D117516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DAD356-D41E-D248-AA75-067A13486B5E}" type="datetimeFigureOut">
              <a:rPr lang="en-US" smtClean="0"/>
              <a:t>12/9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43D53CAF-35AA-EC4A-BD91-13BC08F5481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6DFD68BF-4667-174C-893D-E1683551042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701C66-3126-D34B-BB29-C52EAB5200F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090720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776B6449-F664-344A-A4D5-A5D2F5AC5A3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xmlns="" id="{08396145-FA33-FB43-8C15-C9609B0DEE5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8F2E73ED-2BB4-5047-AE86-0CDDB805CFF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DAD356-D41E-D248-AA75-067A13486B5E}" type="datetimeFigureOut">
              <a:rPr lang="en-US" smtClean="0"/>
              <a:t>12/9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5EE1F7DF-0D65-AC48-BDE3-E3D4AEFD81A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A3F23954-BBEA-F942-9E48-653AD444D39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701C66-3126-D34B-BB29-C52EAB5200F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01061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F066FF96-ED85-B645-9620-3D2333199B3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895A3583-5998-6245-A5AF-11BA41A4F4E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xmlns="" id="{73CD804D-48C0-614F-8059-4D32F1CB5A8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xmlns="" id="{39403B47-C242-B849-892D-616E24C40FA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DAD356-D41E-D248-AA75-067A13486B5E}" type="datetimeFigureOut">
              <a:rPr lang="en-US" smtClean="0"/>
              <a:t>12/9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xmlns="" id="{0F407329-D2DB-A54C-9661-35FD3BC7CC7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xmlns="" id="{53F6D99A-610E-4447-AB19-2680C0D1A7D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701C66-3126-D34B-BB29-C52EAB5200F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9033857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57024E42-239D-AD4D-8E72-43DC83AFF88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xmlns="" id="{B868C3E1-3D82-A54C-A3C9-287FDF92FC6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xmlns="" id="{194FC1E7-00ED-994A-B560-C8A5B51D6CF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xmlns="" id="{5A962725-ABA3-6647-A314-4B1219A0EC3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xmlns="" id="{61848BD1-3114-E34C-ACD1-50D2C4D32D3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xmlns="" id="{9E95E643-6680-D341-84E2-299D2BE69E6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DAD356-D41E-D248-AA75-067A13486B5E}" type="datetimeFigureOut">
              <a:rPr lang="en-US" smtClean="0"/>
              <a:t>12/9/2020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xmlns="" id="{88DBBFCA-E523-194D-B28C-AD34B4DA4DE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xmlns="" id="{62C19833-1B9E-6F42-828F-2C111AA2AEA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701C66-3126-D34B-BB29-C52EAB5200F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3665566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3A27E602-005D-0343-87CB-3B8DCD2D997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xmlns="" id="{5D745820-BDC5-5049-B7F8-6557D57B85E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DAD356-D41E-D248-AA75-067A13486B5E}" type="datetimeFigureOut">
              <a:rPr lang="en-US" smtClean="0"/>
              <a:t>12/9/2020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xmlns="" id="{33377D4B-23D6-634B-A556-79E9E092EE6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xmlns="" id="{F37FBD7E-E4E3-AE4D-BB7C-1D51E20E490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701C66-3126-D34B-BB29-C52EAB5200F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3271770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xmlns="" id="{35087A85-BEC1-B14D-88BB-D8AD92BC310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DAD356-D41E-D248-AA75-067A13486B5E}" type="datetimeFigureOut">
              <a:rPr lang="en-US" smtClean="0"/>
              <a:t>12/9/2020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xmlns="" id="{1CB8805D-C60E-E64B-BE0B-EACEEAAB100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xmlns="" id="{605D7C90-C579-4D41-97B0-01AD9E39466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701C66-3126-D34B-BB29-C52EAB5200F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2882070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87854F53-C2A5-7448-A240-52991F896D9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A857B815-971B-A34C-8B20-05DD2324EAF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xmlns="" id="{A5BBE2A1-1177-1441-8D2B-EC4826021C4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xmlns="" id="{C48E8768-3BB5-3741-B985-5598D100293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DAD356-D41E-D248-AA75-067A13486B5E}" type="datetimeFigureOut">
              <a:rPr lang="en-US" smtClean="0"/>
              <a:t>12/9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xmlns="" id="{C2A3E1EA-A733-D04C-AE90-AAE5E7112C1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xmlns="" id="{93F216DD-916E-2843-B9CA-CABC5B7E84A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701C66-3126-D34B-BB29-C52EAB5200F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4173433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609472A9-A9DC-E246-BBBA-E2C37E92667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xmlns="" id="{A283E36D-05CD-6941-B990-12595E1A3A9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xmlns="" id="{03047A32-A4AD-C548-B703-AB7C7E350D2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xmlns="" id="{EF5F7A06-62CD-6C4E-AFC4-34E57FE137D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DAD356-D41E-D248-AA75-067A13486B5E}" type="datetimeFigureOut">
              <a:rPr lang="en-US" smtClean="0"/>
              <a:t>12/9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xmlns="" id="{A4583DDF-88AF-E94B-B9E6-EB816BBFC10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xmlns="" id="{7E07819E-4AC4-B944-B4CE-7C11E204D20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701C66-3126-D34B-BB29-C52EAB5200F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5442285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xmlns="" id="{726CC79A-DD43-154E-829F-9E4D6B4CF4B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xmlns="" id="{5AA60BD4-DB46-0A41-92E8-68FFDB500EF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7126E72A-CE7D-E84C-9E8B-B1B1E773AB4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DAD356-D41E-D248-AA75-067A13486B5E}" type="datetimeFigureOut">
              <a:rPr lang="en-US" smtClean="0"/>
              <a:t>12/9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118122BD-E32A-D041-B328-8A01B1300B8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E4C43440-FD35-F94F-A262-4D2B701338E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701C66-3126-D34B-BB29-C52EAB5200F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5255342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close up of a map&#10;&#10;Description automatically generated">
            <a:extLst>
              <a:ext uri="{FF2B5EF4-FFF2-40B4-BE49-F238E27FC236}">
                <a16:creationId xmlns:a16="http://schemas.microsoft.com/office/drawing/2014/main" xmlns="" id="{67F8A7F1-A89C-8D49-8EF1-2451C2702BC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09600" y="0"/>
            <a:ext cx="9827941" cy="6142463"/>
          </a:xfrm>
          <a:prstGeom prst="rect">
            <a:avLst/>
          </a:prstGeom>
        </p:spPr>
      </p:pic>
      <p:sp>
        <p:nvSpPr>
          <p:cNvPr id="4" name="Rectangle 3">
            <a:extLst>
              <a:ext uri="{FF2B5EF4-FFF2-40B4-BE49-F238E27FC236}">
                <a16:creationId xmlns:a16="http://schemas.microsoft.com/office/drawing/2014/main" xmlns="" id="{CDEC0AED-F608-3743-89D1-F85673E786AF}"/>
              </a:ext>
            </a:extLst>
          </p:cNvPr>
          <p:cNvSpPr/>
          <p:nvPr/>
        </p:nvSpPr>
        <p:spPr>
          <a:xfrm>
            <a:off x="1117097" y="6282997"/>
            <a:ext cx="8378507" cy="33611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GB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10: (b) </a:t>
            </a:r>
            <a:r>
              <a:rPr lang="en-GB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Number of mosquitoes collected per trap versus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ouse in </a:t>
            </a:r>
            <a:r>
              <a:rPr lang="en-GB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oumousso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ver t</a:t>
            </a:r>
            <a:r>
              <a:rPr lang="en-GB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he study period</a:t>
            </a:r>
          </a:p>
        </p:txBody>
      </p:sp>
    </p:spTree>
    <p:extLst>
      <p:ext uri="{BB962C8B-B14F-4D97-AF65-F5344CB8AC3E}">
        <p14:creationId xmlns:p14="http://schemas.microsoft.com/office/powerpoint/2010/main" val="11754709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close up of a map&#10;&#10;Description automatically generated">
            <a:extLst>
              <a:ext uri="{FF2B5EF4-FFF2-40B4-BE49-F238E27FC236}">
                <a16:creationId xmlns:a16="http://schemas.microsoft.com/office/drawing/2014/main" xmlns="" id="{5D7E3CFE-8E3B-DE42-914E-08F87137D2C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09600" y="289931"/>
            <a:ext cx="9593766" cy="5996104"/>
          </a:xfrm>
          <a:prstGeom prst="rect">
            <a:avLst/>
          </a:prstGeom>
        </p:spPr>
      </p:pic>
      <p:sp>
        <p:nvSpPr>
          <p:cNvPr id="6" name="Rectangle 5">
            <a:extLst>
              <a:ext uri="{FF2B5EF4-FFF2-40B4-BE49-F238E27FC236}">
                <a16:creationId xmlns:a16="http://schemas.microsoft.com/office/drawing/2014/main" xmlns="" id="{5C5C337C-E471-EE4D-916A-DE15C0C5502B}"/>
              </a:ext>
            </a:extLst>
          </p:cNvPr>
          <p:cNvSpPr/>
          <p:nvPr/>
        </p:nvSpPr>
        <p:spPr>
          <a:xfrm>
            <a:off x="1061341" y="6293933"/>
            <a:ext cx="8378507" cy="33977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GB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10: (a) </a:t>
            </a:r>
            <a:r>
              <a:rPr lang="en-GB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Number of mosquitoes collected per trap versus </a:t>
            </a:r>
            <a:r>
              <a:rPr lang="en-GB" sz="1200" dirty="0"/>
              <a:t>house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 VK3 over the study period</a:t>
            </a:r>
            <a:endParaRPr lang="en-GB" sz="1200" dirty="0"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5884922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189</TotalTime>
  <Words>40</Words>
  <Application>Microsoft Office PowerPoint</Application>
  <PresentationFormat>Widescreen</PresentationFormat>
  <Paragraphs>2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rosoft Office User</dc:creator>
  <cp:lastModifiedBy>Dhanalakshmi G.</cp:lastModifiedBy>
  <cp:revision>7</cp:revision>
  <dcterms:created xsi:type="dcterms:W3CDTF">2020-08-26T20:31:24Z</dcterms:created>
  <dcterms:modified xsi:type="dcterms:W3CDTF">2020-12-09T08:34:19Z</dcterms:modified>
</cp:coreProperties>
</file>